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F18F30-3C2A-4BFE-A61B-EA7BF983DBF8}" v="1" dt="2024-08-01T09:22:12.8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530" y="-2078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28F18F30-3C2A-4BFE-A61B-EA7BF983DBF8}"/>
    <pc:docChg chg="modSld">
      <pc:chgData name="Mireille Vankemmelbeke" userId="e2496c92-8ae2-4817-81db-1e2fdf7923b3" providerId="ADAL" clId="{28F18F30-3C2A-4BFE-A61B-EA7BF983DBF8}" dt="2024-08-01T09:22:23.380" v="40" actId="555"/>
      <pc:docMkLst>
        <pc:docMk/>
      </pc:docMkLst>
      <pc:sldChg chg="addSp modSp mod">
        <pc:chgData name="Mireille Vankemmelbeke" userId="e2496c92-8ae2-4817-81db-1e2fdf7923b3" providerId="ADAL" clId="{28F18F30-3C2A-4BFE-A61B-EA7BF983DBF8}" dt="2024-08-01T09:22:23.380" v="40" actId="555"/>
        <pc:sldMkLst>
          <pc:docMk/>
          <pc:sldMk cId="2268793920" sldId="270"/>
        </pc:sldMkLst>
        <pc:spChg chg="add mod">
          <ac:chgData name="Mireille Vankemmelbeke" userId="e2496c92-8ae2-4817-81db-1e2fdf7923b3" providerId="ADAL" clId="{28F18F30-3C2A-4BFE-A61B-EA7BF983DBF8}" dt="2024-08-01T09:22:23.380" v="40" actId="555"/>
          <ac:spMkLst>
            <pc:docMk/>
            <pc:sldMk cId="2268793920" sldId="270"/>
            <ac:spMk id="3" creationId="{93E2DFC7-D9EA-60E0-5B4B-2B241BE390EA}"/>
          </ac:spMkLst>
        </pc:spChg>
        <pc:spChg chg="mod">
          <ac:chgData name="Mireille Vankemmelbeke" userId="e2496c92-8ae2-4817-81db-1e2fdf7923b3" providerId="ADAL" clId="{28F18F30-3C2A-4BFE-A61B-EA7BF983DBF8}" dt="2024-08-01T09:21:44.885" v="29" actId="6549"/>
          <ac:spMkLst>
            <pc:docMk/>
            <pc:sldMk cId="2268793920" sldId="270"/>
            <ac:spMk id="4" creationId="{6C679A7D-5300-C36C-0199-33B42D6BEBE0}"/>
          </ac:spMkLst>
        </pc:spChg>
        <pc:spChg chg="mod">
          <ac:chgData name="Mireille Vankemmelbeke" userId="e2496c92-8ae2-4817-81db-1e2fdf7923b3" providerId="ADAL" clId="{28F18F30-3C2A-4BFE-A61B-EA7BF983DBF8}" dt="2024-08-01T09:22:03.247" v="33" actId="20577"/>
          <ac:spMkLst>
            <pc:docMk/>
            <pc:sldMk cId="2268793920" sldId="270"/>
            <ac:spMk id="5" creationId="{6BAD10FA-2C98-A648-CA57-E529F81BBA0C}"/>
          </ac:spMkLst>
        </pc:spChg>
        <pc:spChg chg="mod">
          <ac:chgData name="Mireille Vankemmelbeke" userId="e2496c92-8ae2-4817-81db-1e2fdf7923b3" providerId="ADAL" clId="{28F18F30-3C2A-4BFE-A61B-EA7BF983DBF8}" dt="2024-08-01T09:22:23.380" v="40" actId="555"/>
          <ac:spMkLst>
            <pc:docMk/>
            <pc:sldMk cId="2268793920" sldId="270"/>
            <ac:spMk id="8" creationId="{388F4722-3142-0E4E-7B51-C1AD4808FA62}"/>
          </ac:spMkLst>
        </pc:spChg>
        <pc:spChg chg="mod">
          <ac:chgData name="Mireille Vankemmelbeke" userId="e2496c92-8ae2-4817-81db-1e2fdf7923b3" providerId="ADAL" clId="{28F18F30-3C2A-4BFE-A61B-EA7BF983DBF8}" dt="2024-08-01T09:21:59.995" v="30" actId="20577"/>
          <ac:spMkLst>
            <pc:docMk/>
            <pc:sldMk cId="2268793920" sldId="270"/>
            <ac:spMk id="9" creationId="{76577009-EBC2-0F5C-D361-900F07FE541F}"/>
          </ac:spMkLst>
        </pc:spChg>
      </pc:sldChg>
    </pc:docChg>
  </pc:docChgLst>
  <pc:docChgLst>
    <pc:chgData name="Mireille Vankemmelbeke" userId="e2496c92-8ae2-4817-81db-1e2fdf7923b3" providerId="ADAL" clId="{E4633E8A-6046-4F54-989F-10D62B938DBF}"/>
    <pc:docChg chg="custSel delSld modSld">
      <pc:chgData name="Mireille Vankemmelbeke" userId="e2496c92-8ae2-4817-81db-1e2fdf7923b3" providerId="ADAL" clId="{E4633E8A-6046-4F54-989F-10D62B938DBF}" dt="2024-06-21T15:48:31.312" v="2" actId="478"/>
      <pc:docMkLst>
        <pc:docMk/>
      </pc:docMkLst>
      <pc:sldChg chg="del">
        <pc:chgData name="Mireille Vankemmelbeke" userId="e2496c92-8ae2-4817-81db-1e2fdf7923b3" providerId="ADAL" clId="{E4633E8A-6046-4F54-989F-10D62B938DBF}" dt="2024-06-21T15:48:19.773" v="0" actId="47"/>
        <pc:sldMkLst>
          <pc:docMk/>
          <pc:sldMk cId="3935331238" sldId="268"/>
        </pc:sldMkLst>
      </pc:sldChg>
      <pc:sldChg chg="del">
        <pc:chgData name="Mireille Vankemmelbeke" userId="e2496c92-8ae2-4817-81db-1e2fdf7923b3" providerId="ADAL" clId="{E4633E8A-6046-4F54-989F-10D62B938DBF}" dt="2024-06-21T15:48:21.127" v="1" actId="47"/>
        <pc:sldMkLst>
          <pc:docMk/>
          <pc:sldMk cId="868960993" sldId="269"/>
        </pc:sldMkLst>
      </pc:sldChg>
      <pc:sldChg chg="delSp mod">
        <pc:chgData name="Mireille Vankemmelbeke" userId="e2496c92-8ae2-4817-81db-1e2fdf7923b3" providerId="ADAL" clId="{E4633E8A-6046-4F54-989F-10D62B938DBF}" dt="2024-06-21T15:48:31.312" v="2" actId="478"/>
        <pc:sldMkLst>
          <pc:docMk/>
          <pc:sldMk cId="2268793920" sldId="270"/>
        </pc:sldMkLst>
        <pc:spChg chg="del">
          <ac:chgData name="Mireille Vankemmelbeke" userId="e2496c92-8ae2-4817-81db-1e2fdf7923b3" providerId="ADAL" clId="{E4633E8A-6046-4F54-989F-10D62B938DBF}" dt="2024-06-21T15:48:31.312" v="2" actId="478"/>
          <ac:spMkLst>
            <pc:docMk/>
            <pc:sldMk cId="2268793920" sldId="270"/>
            <ac:spMk id="3" creationId="{411201C2-C076-747D-F08A-A44B40E18A6D}"/>
          </ac:spMkLst>
        </pc:spChg>
        <pc:spChg chg="del">
          <ac:chgData name="Mireille Vankemmelbeke" userId="e2496c92-8ae2-4817-81db-1e2fdf7923b3" providerId="ADAL" clId="{E4633E8A-6046-4F54-989F-10D62B938DBF}" dt="2024-06-21T15:48:31.312" v="2" actId="478"/>
          <ac:spMkLst>
            <pc:docMk/>
            <pc:sldMk cId="2268793920" sldId="270"/>
            <ac:spMk id="19" creationId="{48315DE5-A130-0BA2-72C1-0450A2A5CF23}"/>
          </ac:spMkLst>
        </pc:spChg>
        <pc:picChg chg="del">
          <ac:chgData name="Mireille Vankemmelbeke" userId="e2496c92-8ae2-4817-81db-1e2fdf7923b3" providerId="ADAL" clId="{E4633E8A-6046-4F54-989F-10D62B938DBF}" dt="2024-06-21T15:48:31.312" v="2" actId="478"/>
          <ac:picMkLst>
            <pc:docMk/>
            <pc:sldMk cId="2268793920" sldId="270"/>
            <ac:picMk id="6" creationId="{620BD82B-C7FC-6143-EE6F-A2BE66DCBC12}"/>
          </ac:picMkLst>
        </pc:picChg>
        <pc:picChg chg="del">
          <ac:chgData name="Mireille Vankemmelbeke" userId="e2496c92-8ae2-4817-81db-1e2fdf7923b3" providerId="ADAL" clId="{E4633E8A-6046-4F54-989F-10D62B938DBF}" dt="2024-06-21T15:48:31.312" v="2" actId="478"/>
          <ac:picMkLst>
            <pc:docMk/>
            <pc:sldMk cId="2268793920" sldId="270"/>
            <ac:picMk id="21" creationId="{F3403A0F-5911-E5E8-5A09-51B2AAF48C9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34F97C-AF6A-4678-A188-E641391358E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972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6C679A7D-5300-C36C-0199-33B42D6BEBE0}"/>
              </a:ext>
            </a:extLst>
          </p:cNvPr>
          <p:cNvSpPr txBox="1"/>
          <p:nvPr/>
        </p:nvSpPr>
        <p:spPr>
          <a:xfrm>
            <a:off x="0" y="688418"/>
            <a:ext cx="6656138" cy="10618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/>
              <a:t>Supplemental Figure 9</a:t>
            </a:r>
            <a:r>
              <a:rPr lang="en-GB" sz="900" dirty="0"/>
              <a:t>. </a:t>
            </a:r>
            <a:r>
              <a:rPr lang="en-GB" sz="900" b="1" dirty="0"/>
              <a:t>A</a:t>
            </a:r>
            <a:r>
              <a:rPr lang="en-GB" sz="900" dirty="0"/>
              <a:t>, Individual tumour growth curves from anti-tumour study testing efficacy of SC134-TCB. DMS79 cells implanted on day 1, PBMCs given on day 3 at 5:1 ratio and 100</a:t>
            </a:r>
            <a:r>
              <a:rPr lang="en-GB" sz="900" dirty="0">
                <a:latin typeface="Symbol"/>
                <a:sym typeface="Symbol" panose="05050102010706020507" pitchFamily="18" charset="2"/>
              </a:rPr>
              <a:t></a:t>
            </a:r>
            <a:r>
              <a:rPr lang="en-GB" sz="900" dirty="0"/>
              <a:t>g SC134-TCB dosed biweekly for three weeks. Curve for the strong regressor (d36 – C8) in the SC134-treated group is marked in bold. </a:t>
            </a:r>
            <a:r>
              <a:rPr lang="en-GB" sz="900" b="1" dirty="0"/>
              <a:t>B</a:t>
            </a:r>
            <a:r>
              <a:rPr lang="en-GB" sz="900" dirty="0"/>
              <a:t>, Gating strategy for determining the level of exhaustion in T cells from terminal tumour samples. </a:t>
            </a:r>
            <a:r>
              <a:rPr lang="en-GB" sz="900" b="1" dirty="0"/>
              <a:t>C</a:t>
            </a:r>
            <a:r>
              <a:rPr lang="en-GB" sz="900" dirty="0"/>
              <a:t>, Individual growth curves from shorter-duration anti-tumour study and </a:t>
            </a:r>
            <a:r>
              <a:rPr lang="en-GB" sz="900" b="1" dirty="0"/>
              <a:t>D</a:t>
            </a:r>
            <a:r>
              <a:rPr lang="en-GB" sz="900" dirty="0"/>
              <a:t>, IHC analysis of CD4 and CD8 T cell infiltration from that study.   Representative example of control (top) and SC134-TCB – treated (bottom) mice are shown.  TTF-1 staining was included to visualise tumour cells.</a:t>
            </a:r>
          </a:p>
          <a:p>
            <a:pPr algn="just"/>
            <a:endParaRPr lang="en-GB" sz="900" dirty="0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1061DE32-896F-447B-5DEA-ACB36D3C14CF}"/>
              </a:ext>
            </a:extLst>
          </p:cNvPr>
          <p:cNvSpPr txBox="1">
            <a:spLocks/>
          </p:cNvSpPr>
          <p:nvPr/>
        </p:nvSpPr>
        <p:spPr>
          <a:xfrm>
            <a:off x="30481" y="22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3C713C9-25BA-E672-0179-9E620305EF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566" y="1586454"/>
            <a:ext cx="4969253" cy="13498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BAD10FA-2C98-A648-CA57-E529F81BBA0C}"/>
              </a:ext>
            </a:extLst>
          </p:cNvPr>
          <p:cNvSpPr txBox="1"/>
          <p:nvPr/>
        </p:nvSpPr>
        <p:spPr>
          <a:xfrm>
            <a:off x="144155" y="2817846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88F4722-3142-0E4E-7B51-C1AD4808FA62}"/>
              </a:ext>
            </a:extLst>
          </p:cNvPr>
          <p:cNvSpPr txBox="1"/>
          <p:nvPr/>
        </p:nvSpPr>
        <p:spPr>
          <a:xfrm>
            <a:off x="144155" y="4429245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577009-EBC2-0F5C-D361-900F07FE541F}"/>
              </a:ext>
            </a:extLst>
          </p:cNvPr>
          <p:cNvSpPr txBox="1"/>
          <p:nvPr/>
        </p:nvSpPr>
        <p:spPr>
          <a:xfrm>
            <a:off x="144155" y="1570452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95FA8D2-E6CA-5C56-0855-D3C356A539B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21" t="-227"/>
          <a:stretch/>
        </p:blipFill>
        <p:spPr>
          <a:xfrm>
            <a:off x="3045460" y="4447119"/>
            <a:ext cx="3155590" cy="164888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54F9ADC-933E-3BD5-B1CF-8E6048D4D8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404" y="2890364"/>
            <a:ext cx="2160000" cy="144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4512802-B1EB-520D-C5F5-52F1ED5766A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6730" y="4441634"/>
            <a:ext cx="1723390" cy="188804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3E2DFC7-D9EA-60E0-5B4B-2B241BE390EA}"/>
              </a:ext>
            </a:extLst>
          </p:cNvPr>
          <p:cNvSpPr txBox="1"/>
          <p:nvPr/>
        </p:nvSpPr>
        <p:spPr>
          <a:xfrm>
            <a:off x="2727335" y="4429245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26879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0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8-01T09:22:27Z</dcterms:modified>
</cp:coreProperties>
</file>